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45AF0B-B360-42AA-B56B-337290744F4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598840-FCF4-4592-8D93-5F6FF1F3F2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C6A22-1684-46E7-B857-5E1CF91E73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094602-F5D1-4B3E-BDA6-2D9450738F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7F6B8-AF81-4D17-B902-C92C53A42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14652E-A7F7-4FBA-80B3-92472073D2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E96B0-5727-4478-BAF6-A87B2C03D1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6F6682-0F31-4BDA-AAEB-BAA345D2DD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8211DB-909D-4D61-8AEE-3C7609F4C6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6D6C2-823E-49C8-9C9C-CC51376C88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B278D-6BDE-4601-8A27-E08FE113C3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10CE9-7465-4D19-ADC1-E37D65BF6C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A39B2A-5206-4830-9753-2783641506F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7225560"/>
            <a:ext cx="632448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Figure S7.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Dose-response cytotoxicity curves upon cisplatin (A) and paclitaxel (B) treatment of SKOV3 cells following shRNA-mediated RUNX2 knockdown. Treatment responses of the </a:t>
            </a:r>
            <a:r>
              <a:rPr b="0" lang="en-CA" sz="1400" spc="-1" strike="noStrike">
                <a:solidFill>
                  <a:srgbClr val="000000"/>
                </a:solidFill>
                <a:latin typeface="Arial"/>
                <a:ea typeface="宋体"/>
              </a:rPr>
              <a:t>shRNA-RUNX2 clones cl-sh3 and cl-sh6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were compared to to the mock-transfected control (ctrl) clone. Error bars denote ± SEM. All the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P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 value are &gt; 0.05 according to the one-way ANOVA analysi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415600" y="3301920"/>
            <a:ext cx="2122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600" spc="-1" strike="noStrike">
                <a:solidFill>
                  <a:srgbClr val="000000"/>
                </a:solidFill>
                <a:latin typeface="Arial"/>
              </a:rPr>
              <a:t>A. Cisplatin treat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287800" y="6705720"/>
            <a:ext cx="2213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600" spc="-1" strike="noStrike">
                <a:solidFill>
                  <a:srgbClr val="000000"/>
                </a:solidFill>
                <a:latin typeface="Arial"/>
              </a:rPr>
              <a:t>B. Paclitaxel treatmen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495360" y="571680"/>
            <a:ext cx="2922480" cy="269856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3506760" y="609480"/>
            <a:ext cx="2894040" cy="270036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3"/>
          <a:stretch/>
        </p:blipFill>
        <p:spPr>
          <a:xfrm>
            <a:off x="520560" y="3797280"/>
            <a:ext cx="2922840" cy="269892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4"/>
          <a:stretch/>
        </p:blipFill>
        <p:spPr>
          <a:xfrm>
            <a:off x="3530520" y="3784680"/>
            <a:ext cx="2922840" cy="2698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9T15:54:58Z</dcterms:created>
  <dc:creator>Dbatch</dc:creator>
  <dc:description/>
  <dc:language>en-US</dc:language>
  <cp:lastModifiedBy>Dbatch</cp:lastModifiedBy>
  <dcterms:modified xsi:type="dcterms:W3CDTF">2013-09-10T16:33:51Z</dcterms:modified>
  <cp:revision>13</cp:revision>
  <dc:subject/>
  <dc:title>Diapositive 1</dc:title>
</cp:coreProperties>
</file>